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5.wmf" ContentType="image/x-wmf"/>
  <Override PartName="/ppt/media/image6.wmf" ContentType="image/x-wmf"/>
  <Override PartName="/ppt/media/image7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10825163" cy="81216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A21AD2-98B0-4F93-95B9-A03CD6BAEA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41080" y="1893600"/>
            <a:ext cx="974412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41080" y="4693320"/>
            <a:ext cx="974412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57929-2013-4FEB-BBE0-C01FEA2D8A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41080" y="1893600"/>
            <a:ext cx="475488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533920" y="1893600"/>
            <a:ext cx="475488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41080" y="4693320"/>
            <a:ext cx="475488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533920" y="4693320"/>
            <a:ext cx="475488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927AE0-2CCA-4F4F-8108-69A0E45A67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41080" y="1893600"/>
            <a:ext cx="313740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35800" y="1893600"/>
            <a:ext cx="313740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130520" y="1893600"/>
            <a:ext cx="313740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41080" y="4693320"/>
            <a:ext cx="313740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35800" y="4693320"/>
            <a:ext cx="313740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130520" y="4693320"/>
            <a:ext cx="313740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095B9C-4397-4847-9008-3BAC95FC84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41080" y="1893600"/>
            <a:ext cx="9744120" cy="5359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24"/>
              </a:spcBef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7771BD-9EBA-4C5C-8AE3-97B592E9D1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41080" y="1893600"/>
            <a:ext cx="9744120" cy="535932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8D4A5A-CE65-4790-BE4D-FF3FCEFB66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41080" y="1893600"/>
            <a:ext cx="4754880" cy="535932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533920" y="1893600"/>
            <a:ext cx="4754880" cy="535932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436638-83E3-4ADB-BA49-2148EB2D4F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AC55E0-B554-45B1-ADF1-E3572E2623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41080" y="325080"/>
            <a:ext cx="9744120" cy="6277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24"/>
              </a:spcBef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951425-75C1-4B4D-A667-129C566218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41080" y="1893600"/>
            <a:ext cx="475488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533920" y="1893600"/>
            <a:ext cx="4754880" cy="535932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41080" y="4693320"/>
            <a:ext cx="475488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446564-E4BD-4B25-A319-9D5C3B08F0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41080" y="1893600"/>
            <a:ext cx="4754880" cy="535932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533920" y="1893600"/>
            <a:ext cx="475488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533920" y="4693320"/>
            <a:ext cx="475488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394EA-6F5B-47FC-A32C-593DF35F70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41080" y="1893600"/>
            <a:ext cx="475488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533920" y="1893600"/>
            <a:ext cx="475488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41080" y="4693320"/>
            <a:ext cx="9744120" cy="25563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FD7D5-7A38-4D56-A4DF-EE2BAFA1D8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ctr">
            <a:noAutofit/>
          </a:bodyPr>
          <a:p>
            <a:pPr indent="0" algn="ct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41080" y="1893600"/>
            <a:ext cx="9744120" cy="535932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rmAutofit/>
          </a:bodyPr>
          <a:p>
            <a:pPr marL="398520" indent="-398520">
              <a:spcBef>
                <a:spcPts val="924"/>
              </a:spcBef>
              <a:buClr>
                <a:srgbClr val="000000"/>
              </a:buClr>
              <a:buFont typeface="Arial"/>
              <a:buChar char="•"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1" marL="861840" indent="-331560">
              <a:spcBef>
                <a:spcPts val="924"/>
              </a:spcBef>
              <a:buClr>
                <a:srgbClr val="000000"/>
              </a:buClr>
              <a:buFont typeface="Arial"/>
              <a:buChar char="–"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2" marL="1327320" indent="-265320">
              <a:spcBef>
                <a:spcPts val="924"/>
              </a:spcBef>
              <a:buClr>
                <a:srgbClr val="000000"/>
              </a:buClr>
              <a:buFont typeface="Arial"/>
              <a:buChar char="•"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3" marL="1859040" indent="-266760">
              <a:spcBef>
                <a:spcPts val="924"/>
              </a:spcBef>
              <a:buClr>
                <a:srgbClr val="000000"/>
              </a:buClr>
              <a:buFont typeface="Arial"/>
              <a:buChar char="–"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4" marL="2389320" indent="-26532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5" marL="2389320" indent="-26532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6" marL="2389320" indent="-26532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41440" y="7394400"/>
            <a:ext cx="2525760" cy="5637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697200" y="7394400"/>
            <a:ext cx="3432240" cy="5637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759800" y="7394400"/>
            <a:ext cx="2525760" cy="563760"/>
          </a:xfrm>
          <a:prstGeom prst="rect">
            <a:avLst/>
          </a:prstGeom>
          <a:noFill/>
          <a:ln w="0">
            <a:noFill/>
          </a:ln>
        </p:spPr>
        <p:txBody>
          <a:bodyPr lIns="106200" rIns="106200" tIns="52920" bIns="52920" anchor="t">
            <a:noAutofit/>
          </a:bodyPr>
          <a:lstStyle>
            <a:lvl1pPr indent="0" algn="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  <a:defRPr b="0" lang="zh-CN" sz="1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062000"/>
                <a:tab algn="l" pos="2124000"/>
                <a:tab algn="l" pos="3186000"/>
                <a:tab algn="l" pos="4248000"/>
                <a:tab algn="l" pos="5310360"/>
                <a:tab algn="l" pos="6372360"/>
                <a:tab algn="l" pos="7434360"/>
                <a:tab algn="l" pos="8496360"/>
                <a:tab algn="l" pos="9558360"/>
                <a:tab algn="l" pos="10620360"/>
              </a:tabLst>
            </a:pPr>
            <a:fld id="{DA057D44-4F47-47B2-9190-FBD1AF4D8441}" type="slidenum">
              <a:rPr b="0" lang="zh-CN" sz="1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7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193680" y="73080"/>
            <a:ext cx="4794120" cy="37926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tretch/>
        </p:blipFill>
        <p:spPr>
          <a:xfrm>
            <a:off x="5489640" y="9360"/>
            <a:ext cx="4792680" cy="39117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" descr=""/>
          <p:cNvPicPr/>
          <p:nvPr/>
        </p:nvPicPr>
        <p:blipFill>
          <a:blip r:embed="rId3"/>
          <a:stretch/>
        </p:blipFill>
        <p:spPr>
          <a:xfrm>
            <a:off x="120600" y="4057560"/>
            <a:ext cx="4911840" cy="4040280"/>
          </a:xfrm>
          <a:prstGeom prst="rect">
            <a:avLst/>
          </a:prstGeom>
          <a:ln w="0">
            <a:noFill/>
          </a:ln>
        </p:spPr>
      </p:pic>
      <p:sp>
        <p:nvSpPr>
          <p:cNvPr id="44" name="矩形 1"/>
          <p:cNvSpPr/>
          <p:nvPr/>
        </p:nvSpPr>
        <p:spPr>
          <a:xfrm>
            <a:off x="5337000" y="4094280"/>
            <a:ext cx="5257800" cy="406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 fig1. CCl</a:t>
            </a:r>
            <a:r>
              <a:rPr b="1" lang="en-US" sz="21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1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reatment induced autophagic activation at 12-24h and inhibition at 72h.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epG2 cells stable expressing pHluorin-mKate2-hLC3 were treated with 0.05% CCl</a:t>
            </a:r>
            <a:r>
              <a:rPr b="0" lang="en-US" sz="21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 vehicle </a:t>
            </a:r>
            <a:r>
              <a:rPr b="0" lang="zh-CN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（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MSO</a:t>
            </a:r>
            <a:r>
              <a:rPr b="0" lang="zh-CN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）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 an indicated period. 2h before cell fixation,  100ng/ml Bafilomycin A1 was added into the culture medium. 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矩形 1"/>
          <p:cNvSpPr/>
          <p:nvPr/>
        </p:nvSpPr>
        <p:spPr>
          <a:xfrm>
            <a:off x="1069920" y="4821120"/>
            <a:ext cx="8077320" cy="262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 fig2. CCl</a:t>
            </a:r>
            <a:r>
              <a:rPr b="1" lang="en-US" sz="21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1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reatment induced autophagic activation at 12-24h and inhibition at 72h.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epG2 cells were treated with 0.05% CCl</a:t>
            </a:r>
            <a:r>
              <a:rPr b="0" lang="en-US" sz="21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 vehicle </a:t>
            </a:r>
            <a:r>
              <a:rPr b="0" lang="zh-CN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（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MSO</a:t>
            </a:r>
            <a:r>
              <a:rPr b="0" lang="zh-CN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）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 an indicated period. 2h before cell harvesting,  100ng/ml Bafilomycin A1 was added into the culture medium. LC3-II/LC3-I ratio was calculated to evaluate the autophagy flux.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组合 3"/>
          <p:cNvGrpSpPr/>
          <p:nvPr/>
        </p:nvGrpSpPr>
        <p:grpSpPr>
          <a:xfrm>
            <a:off x="2136600" y="326880"/>
            <a:ext cx="6407280" cy="4537080"/>
            <a:chOff x="2136600" y="326880"/>
            <a:chExt cx="6407280" cy="4537080"/>
          </a:xfrm>
        </p:grpSpPr>
        <p:pic>
          <p:nvPicPr>
            <p:cNvPr id="47" name="Picture 3" descr="H:\revising\JPG\JPG\补充图\3.jpg"/>
            <p:cNvPicPr/>
            <p:nvPr/>
          </p:nvPicPr>
          <p:blipFill>
            <a:blip r:embed="rId1"/>
            <a:srcRect l="0" t="0" r="0" b="36981"/>
            <a:stretch/>
          </p:blipFill>
          <p:spPr>
            <a:xfrm>
              <a:off x="2136600" y="326880"/>
              <a:ext cx="6407280" cy="4537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直接连接符 2"/>
            <p:cNvSpPr/>
            <p:nvPr/>
          </p:nvSpPr>
          <p:spPr>
            <a:xfrm>
              <a:off x="4740120" y="1684800"/>
              <a:ext cx="0" cy="3123360"/>
            </a:xfrm>
            <a:prstGeom prst="line">
              <a:avLst/>
            </a:prstGeom>
            <a:ln w="64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直接连接符 5"/>
            <p:cNvSpPr/>
            <p:nvPr/>
          </p:nvSpPr>
          <p:spPr>
            <a:xfrm>
              <a:off x="6162480" y="1697760"/>
              <a:ext cx="0" cy="3123360"/>
            </a:xfrm>
            <a:prstGeom prst="line">
              <a:avLst/>
            </a:prstGeom>
            <a:ln w="64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内容占位符 7175"/>
          <p:cNvGraphicFramePr/>
          <p:nvPr/>
        </p:nvGraphicFramePr>
        <p:xfrm>
          <a:off x="1832040" y="174600"/>
          <a:ext cx="6019560" cy="45212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1" name="内容占位符 717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832040" y="174600"/>
                    <a:ext cx="6019560" cy="4521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矩形 1"/>
          <p:cNvSpPr/>
          <p:nvPr/>
        </p:nvSpPr>
        <p:spPr>
          <a:xfrm>
            <a:off x="1069920" y="4821120"/>
            <a:ext cx="8077320" cy="310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 fig3. Fast leads to reduced body weight of rats treated with CCl</a:t>
            </a:r>
            <a:r>
              <a:rPr b="1" lang="en-US" sz="21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1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ubcutaneous injection for 8 weeks.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D rats were injected with 1 ml/kg 50% (v/v) CCl</a:t>
            </a:r>
            <a:r>
              <a:rPr b="0" lang="en-US" sz="21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 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r olive oil (n=3) twice a week for 8 weeks, CCl</a:t>
            </a:r>
            <a:r>
              <a:rPr b="0" lang="en-US" sz="21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reated rats were starved for 24h twice a week (n=6) or 48h once a week (n=5) or without starvation (n=6). Rats were weighted per week. During starvation these animals had free access to drinking water. *p &lt; 0.05 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3" name="对象 5123"/>
          <p:cNvGraphicFramePr/>
          <p:nvPr/>
        </p:nvGraphicFramePr>
        <p:xfrm>
          <a:off x="5522760" y="276120"/>
          <a:ext cx="4953240" cy="35416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4" name="对象 512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522760" y="276120"/>
                    <a:ext cx="4953240" cy="3541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5" name="对象 5153"/>
          <p:cNvGraphicFramePr/>
          <p:nvPr/>
        </p:nvGraphicFramePr>
        <p:xfrm>
          <a:off x="237960" y="474840"/>
          <a:ext cx="4800600" cy="34351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6" name="对象 515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37960" y="474840"/>
                    <a:ext cx="4800600" cy="3435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7" name="矩形 1"/>
          <p:cNvSpPr/>
          <p:nvPr/>
        </p:nvSpPr>
        <p:spPr>
          <a:xfrm>
            <a:off x="917640" y="4059360"/>
            <a:ext cx="8610480" cy="39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 fig4. ALT and AST are not suitable for the characterization of liver function in case of starvation. a 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basal level of ALT and AST, the signs of liver function, were elevated by 24 and 48 hours of starvation. n=3. </a:t>
            </a:r>
            <a:r>
              <a:rPr b="1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Liver function has not been improved by the fast. SD rats were injected with 1 ml/kg 50% (v/v) CCl</a:t>
            </a:r>
            <a:r>
              <a:rPr b="0" lang="en-US" sz="21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 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r olive oil (n=3) twice a week for 8 weeks, CCl</a:t>
            </a:r>
            <a:r>
              <a:rPr b="0" lang="en-US" sz="21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0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reated rats were starved for 24h twice a week (n=6) or 48h once a week (n=5) or without starvation (n=6). Rats were weighted per week. During starvation these animals had free access to drinking water. *p &lt; 0.05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"/>
          <p:cNvSpPr/>
          <p:nvPr/>
        </p:nvSpPr>
        <p:spPr>
          <a:xfrm>
            <a:off x="155520" y="100080"/>
            <a:ext cx="6094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5"/>
          <p:cNvSpPr/>
          <p:nvPr/>
        </p:nvSpPr>
        <p:spPr>
          <a:xfrm>
            <a:off x="5565600" y="98280"/>
            <a:ext cx="609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5-16T10:41:33Z</dcterms:created>
  <dc:creator>Administrator</dc:creator>
  <dc:description/>
  <dc:language>en-US</dc:language>
  <cp:lastModifiedBy>User</cp:lastModifiedBy>
  <dcterms:modified xsi:type="dcterms:W3CDTF">2018-11-24T14:03:43Z</dcterms:modified>
  <cp:revision>2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400</vt:lpwstr>
  </property>
  <property fmtid="{D5CDD505-2E9C-101B-9397-08002B2CF9AE}" pid="3" name="Version">
    <vt:r8>1</vt:r8>
  </property>
</Properties>
</file>